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2304" y="-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fudal\Documents\articles\2019%20Structure%20AvrLm5-9\PLOS%20Pathogens\revision%201\Test%20patho%20complemetnation%20famille%20structura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fudal\Documents\articles\2019%20Structure%20AvrLm5-9\PLOS%20Pathogens\revision%201\Test%20patho%20complemetnation%20famille%20structura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fudal\Documents\articles\2019%20Structure%20AvrLm5-9\PLOS%20Pathogens\revision%201\Test%20patho%20complemetnation%20famille%20structural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fr-FR" dirty="0"/>
              <a:t>15.23.4.1 (</a:t>
            </a:r>
            <a:r>
              <a:rPr lang="fr-FR" i="1" dirty="0"/>
              <a:t>Rlm7</a:t>
            </a:r>
            <a:r>
              <a:rPr lang="fr-FR" dirty="0"/>
              <a:t>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10 DPI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utagenèse RYRE'!$AC$3:$AY$3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22047927592204919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.15075567228888173</c:v>
                  </c:pt>
                  <c:pt idx="8">
                    <c:v>0</c:v>
                  </c:pt>
                  <c:pt idx="9">
                    <c:v>0</c:v>
                  </c:pt>
                  <c:pt idx="10">
                    <c:v>0.158113883008419</c:v>
                  </c:pt>
                  <c:pt idx="11">
                    <c:v>0.16666666666666671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74801324154309523</c:v>
                  </c:pt>
                  <c:pt idx="18">
                    <c:v>0.25</c:v>
                  </c:pt>
                  <c:pt idx="19">
                    <c:v>0.61237243569579447</c:v>
                  </c:pt>
                  <c:pt idx="20">
                    <c:v>0.66666666666666685</c:v>
                  </c:pt>
                  <c:pt idx="21">
                    <c:v>0.23145502494313785</c:v>
                  </c:pt>
                  <c:pt idx="22">
                    <c:v>0.74721705904866298</c:v>
                  </c:pt>
                </c:numCache>
              </c:numRef>
            </c:plus>
            <c:minus>
              <c:numRef>
                <c:f>'mutagenèse RYRE'!$AC$3:$AY$3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22047927592204919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.15075567228888173</c:v>
                  </c:pt>
                  <c:pt idx="8">
                    <c:v>0</c:v>
                  </c:pt>
                  <c:pt idx="9">
                    <c:v>0</c:v>
                  </c:pt>
                  <c:pt idx="10">
                    <c:v>0.158113883008419</c:v>
                  </c:pt>
                  <c:pt idx="11">
                    <c:v>0.16666666666666671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74801324154309523</c:v>
                  </c:pt>
                  <c:pt idx="18">
                    <c:v>0.25</c:v>
                  </c:pt>
                  <c:pt idx="19">
                    <c:v>0.61237243569579447</c:v>
                  </c:pt>
                  <c:pt idx="20">
                    <c:v>0.66666666666666685</c:v>
                  </c:pt>
                  <c:pt idx="21">
                    <c:v>0.23145502494313785</c:v>
                  </c:pt>
                  <c:pt idx="22">
                    <c:v>0.74721705904866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utagenèse RYRE'!$AC$1:$AY$1</c:f>
              <c:strCache>
                <c:ptCount val="23"/>
                <c:pt idx="0">
                  <c:v>jn3</c:v>
                </c:pt>
                <c:pt idx="1">
                  <c:v>G06E107</c:v>
                </c:pt>
                <c:pt idx="2">
                  <c:v>JN2</c:v>
                </c:pt>
                <c:pt idx="3">
                  <c:v>G06E107-A4-7R100P-1</c:v>
                </c:pt>
                <c:pt idx="4">
                  <c:v>G06E107-A4-7R100P-2</c:v>
                </c:pt>
                <c:pt idx="5">
                  <c:v>G06E107-A4-7R100P-3</c:v>
                </c:pt>
                <c:pt idx="6">
                  <c:v>G06E107-A4-7R100P-4</c:v>
                </c:pt>
                <c:pt idx="7">
                  <c:v>G06E107-A4-7R100P-5</c:v>
                </c:pt>
                <c:pt idx="8">
                  <c:v>G06E107-A4-7F102S-1</c:v>
                </c:pt>
                <c:pt idx="9">
                  <c:v>G06E107-A4-7F102S-3</c:v>
                </c:pt>
                <c:pt idx="10">
                  <c:v>G06E107-A4-7F102S-4</c:v>
                </c:pt>
                <c:pt idx="11">
                  <c:v>G06E107-A4-7F102S-5</c:v>
                </c:pt>
                <c:pt idx="12">
                  <c:v>G06E107-A4-7F102S-6</c:v>
                </c:pt>
                <c:pt idx="13">
                  <c:v>G06E107-a4-A7F102SG120R-1</c:v>
                </c:pt>
                <c:pt idx="14">
                  <c:v>G06E107-a4-A7F102SG120R-2</c:v>
                </c:pt>
                <c:pt idx="15">
                  <c:v>G06E107-a4-A7F102SG120R-3</c:v>
                </c:pt>
                <c:pt idx="16">
                  <c:v>G06E107-a4-A7F102SG120R-4</c:v>
                </c:pt>
                <c:pt idx="17">
                  <c:v>G06E107-a4-A7F102SG120R-5</c:v>
                </c:pt>
                <c:pt idx="18">
                  <c:v>G06E107-A4-7S112R-1</c:v>
                </c:pt>
                <c:pt idx="19">
                  <c:v>G06E107-A4-7S112R-2</c:v>
                </c:pt>
                <c:pt idx="20">
                  <c:v>G06E107-A4-7S112R-3</c:v>
                </c:pt>
                <c:pt idx="21">
                  <c:v>G06E107-A4-7S112R-4</c:v>
                </c:pt>
                <c:pt idx="22">
                  <c:v>G06E107-A4-7S112R-7</c:v>
                </c:pt>
              </c:strCache>
            </c:strRef>
          </c:cat>
          <c:val>
            <c:numRef>
              <c:f>'mutagenèse RYRE'!$AC$2:$AY$2</c:f>
              <c:numCache>
                <c:formatCode>General</c:formatCode>
                <c:ptCount val="23"/>
                <c:pt idx="0">
                  <c:v>1</c:v>
                </c:pt>
                <c:pt idx="1">
                  <c:v>4.2222222222222223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.0909090909090908</c:v>
                </c:pt>
                <c:pt idx="8">
                  <c:v>1</c:v>
                </c:pt>
                <c:pt idx="9">
                  <c:v>1</c:v>
                </c:pt>
                <c:pt idx="10">
                  <c:v>1.1000000000000001</c:v>
                </c:pt>
                <c:pt idx="11">
                  <c:v>1.1111111111111112</c:v>
                </c:pt>
                <c:pt idx="12">
                  <c:v>1</c:v>
                </c:pt>
                <c:pt idx="13">
                  <c:v>5</c:v>
                </c:pt>
                <c:pt idx="14">
                  <c:v>5</c:v>
                </c:pt>
                <c:pt idx="15">
                  <c:v>5</c:v>
                </c:pt>
                <c:pt idx="16">
                  <c:v>5</c:v>
                </c:pt>
                <c:pt idx="17">
                  <c:v>4.2857142857142856</c:v>
                </c:pt>
                <c:pt idx="18">
                  <c:v>4.333333333333333</c:v>
                </c:pt>
                <c:pt idx="19">
                  <c:v>4</c:v>
                </c:pt>
                <c:pt idx="20">
                  <c:v>4.4444444444444446</c:v>
                </c:pt>
                <c:pt idx="21">
                  <c:v>4.75</c:v>
                </c:pt>
                <c:pt idx="22">
                  <c:v>3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EA-49C5-85A4-ACB73DD5ABCE}"/>
            </c:ext>
          </c:extLst>
        </c:ser>
        <c:ser>
          <c:idx val="1"/>
          <c:order val="1"/>
          <c:tx>
            <c:v>14 DPI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utagenèse RYRE'!$AC$5:$AY$5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15811388300841897</c:v>
                  </c:pt>
                  <c:pt idx="2">
                    <c:v>0</c:v>
                  </c:pt>
                  <c:pt idx="3">
                    <c:v>0.33747427885527653</c:v>
                  </c:pt>
                  <c:pt idx="4">
                    <c:v>0.20225995873897265</c:v>
                  </c:pt>
                  <c:pt idx="5">
                    <c:v>0.23354968324845699</c:v>
                  </c:pt>
                  <c:pt idx="6">
                    <c:v>0.23354968324845699</c:v>
                  </c:pt>
                  <c:pt idx="7">
                    <c:v>0.23354968324845699</c:v>
                  </c:pt>
                  <c:pt idx="8">
                    <c:v>0</c:v>
                  </c:pt>
                  <c:pt idx="9">
                    <c:v>0.16666666666666671</c:v>
                  </c:pt>
                  <c:pt idx="10">
                    <c:v>0.24152294576982405</c:v>
                  </c:pt>
                  <c:pt idx="11">
                    <c:v>0.22047927592204919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74801324154309523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.2022599587389726</c:v>
                  </c:pt>
                </c:numCache>
              </c:numRef>
            </c:plus>
            <c:minus>
              <c:numRef>
                <c:f>'mutagenèse RYRE'!$AC$5:$AY$5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15811388300841897</c:v>
                  </c:pt>
                  <c:pt idx="2">
                    <c:v>0</c:v>
                  </c:pt>
                  <c:pt idx="3">
                    <c:v>0.33747427885527653</c:v>
                  </c:pt>
                  <c:pt idx="4">
                    <c:v>0.20225995873897265</c:v>
                  </c:pt>
                  <c:pt idx="5">
                    <c:v>0.23354968324845699</c:v>
                  </c:pt>
                  <c:pt idx="6">
                    <c:v>0.23354968324845699</c:v>
                  </c:pt>
                  <c:pt idx="7">
                    <c:v>0.23354968324845699</c:v>
                  </c:pt>
                  <c:pt idx="8">
                    <c:v>0</c:v>
                  </c:pt>
                  <c:pt idx="9">
                    <c:v>0.16666666666666671</c:v>
                  </c:pt>
                  <c:pt idx="10">
                    <c:v>0.24152294576982405</c:v>
                  </c:pt>
                  <c:pt idx="11">
                    <c:v>0.22047927592204919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.74801324154309523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.20225995873897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utagenèse RYRE'!$AC$1:$AY$1</c:f>
              <c:strCache>
                <c:ptCount val="23"/>
                <c:pt idx="0">
                  <c:v>jn3</c:v>
                </c:pt>
                <c:pt idx="1">
                  <c:v>G06E107</c:v>
                </c:pt>
                <c:pt idx="2">
                  <c:v>JN2</c:v>
                </c:pt>
                <c:pt idx="3">
                  <c:v>G06E107-A4-7R100P-1</c:v>
                </c:pt>
                <c:pt idx="4">
                  <c:v>G06E107-A4-7R100P-2</c:v>
                </c:pt>
                <c:pt idx="5">
                  <c:v>G06E107-A4-7R100P-3</c:v>
                </c:pt>
                <c:pt idx="6">
                  <c:v>G06E107-A4-7R100P-4</c:v>
                </c:pt>
                <c:pt idx="7">
                  <c:v>G06E107-A4-7R100P-5</c:v>
                </c:pt>
                <c:pt idx="8">
                  <c:v>G06E107-A4-7F102S-1</c:v>
                </c:pt>
                <c:pt idx="9">
                  <c:v>G06E107-A4-7F102S-3</c:v>
                </c:pt>
                <c:pt idx="10">
                  <c:v>G06E107-A4-7F102S-4</c:v>
                </c:pt>
                <c:pt idx="11">
                  <c:v>G06E107-A4-7F102S-5</c:v>
                </c:pt>
                <c:pt idx="12">
                  <c:v>G06E107-A4-7F102S-6</c:v>
                </c:pt>
                <c:pt idx="13">
                  <c:v>G06E107-a4-A7F102SG120R-1</c:v>
                </c:pt>
                <c:pt idx="14">
                  <c:v>G06E107-a4-A7F102SG120R-2</c:v>
                </c:pt>
                <c:pt idx="15">
                  <c:v>G06E107-a4-A7F102SG120R-3</c:v>
                </c:pt>
                <c:pt idx="16">
                  <c:v>G06E107-a4-A7F102SG120R-4</c:v>
                </c:pt>
                <c:pt idx="17">
                  <c:v>G06E107-a4-A7F102SG120R-5</c:v>
                </c:pt>
                <c:pt idx="18">
                  <c:v>G06E107-A4-7S112R-1</c:v>
                </c:pt>
                <c:pt idx="19">
                  <c:v>G06E107-A4-7S112R-2</c:v>
                </c:pt>
                <c:pt idx="20">
                  <c:v>G06E107-A4-7S112R-3</c:v>
                </c:pt>
                <c:pt idx="21">
                  <c:v>G06E107-A4-7S112R-4</c:v>
                </c:pt>
                <c:pt idx="22">
                  <c:v>G06E107-A4-7S112R-7</c:v>
                </c:pt>
              </c:strCache>
            </c:strRef>
          </c:cat>
          <c:val>
            <c:numRef>
              <c:f>'mutagenèse RYRE'!$AC$4:$AY$4</c:f>
              <c:numCache>
                <c:formatCode>General</c:formatCode>
                <c:ptCount val="23"/>
                <c:pt idx="0">
                  <c:v>1</c:v>
                </c:pt>
                <c:pt idx="1">
                  <c:v>4.0999999999999996</c:v>
                </c:pt>
                <c:pt idx="2">
                  <c:v>1</c:v>
                </c:pt>
                <c:pt idx="3">
                  <c:v>1.3</c:v>
                </c:pt>
                <c:pt idx="4">
                  <c:v>1.1818181818181819</c:v>
                </c:pt>
                <c:pt idx="5">
                  <c:v>1.2727272727272727</c:v>
                </c:pt>
                <c:pt idx="6">
                  <c:v>1.2727272727272727</c:v>
                </c:pt>
                <c:pt idx="7">
                  <c:v>1.2727272727272727</c:v>
                </c:pt>
                <c:pt idx="8">
                  <c:v>1</c:v>
                </c:pt>
                <c:pt idx="9">
                  <c:v>1.1111111111111112</c:v>
                </c:pt>
                <c:pt idx="10">
                  <c:v>1.3</c:v>
                </c:pt>
                <c:pt idx="11">
                  <c:v>1.2222222222222223</c:v>
                </c:pt>
                <c:pt idx="12">
                  <c:v>1</c:v>
                </c:pt>
                <c:pt idx="13">
                  <c:v>5</c:v>
                </c:pt>
                <c:pt idx="14">
                  <c:v>5</c:v>
                </c:pt>
                <c:pt idx="15">
                  <c:v>5</c:v>
                </c:pt>
                <c:pt idx="16">
                  <c:v>5</c:v>
                </c:pt>
                <c:pt idx="17">
                  <c:v>4.2857142857142856</c:v>
                </c:pt>
                <c:pt idx="18">
                  <c:v>4.4000000000000004</c:v>
                </c:pt>
                <c:pt idx="19">
                  <c:v>4.4000000000000004</c:v>
                </c:pt>
                <c:pt idx="20">
                  <c:v>4.67</c:v>
                </c:pt>
                <c:pt idx="21">
                  <c:v>4.8</c:v>
                </c:pt>
                <c:pt idx="22">
                  <c:v>4.1818181818181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0EA-49C5-85A4-ACB73DD5AB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85035744"/>
        <c:axId val="1185036832"/>
      </c:barChart>
      <c:catAx>
        <c:axId val="1185035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185036832"/>
        <c:crosses val="autoZero"/>
        <c:auto val="1"/>
        <c:lblAlgn val="ctr"/>
        <c:lblOffset val="100"/>
        <c:noMultiLvlLbl val="0"/>
      </c:catAx>
      <c:valAx>
        <c:axId val="1185036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185035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fr-FR" dirty="0"/>
              <a:t>Pixel (</a:t>
            </a:r>
            <a:r>
              <a:rPr lang="fr-FR" i="1" dirty="0"/>
              <a:t>Rlm4</a:t>
            </a:r>
            <a:r>
              <a:rPr lang="fr-FR" dirty="0"/>
              <a:t>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10DPI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utagenèse RYRE'!$C$11:$Y$11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45226701686664555</c:v>
                  </c:pt>
                  <c:pt idx="2">
                    <c:v>0.21081851067789195</c:v>
                  </c:pt>
                  <c:pt idx="3">
                    <c:v>0.25226248955475655</c:v>
                  </c:pt>
                  <c:pt idx="4">
                    <c:v>0.35355339059327379</c:v>
                  </c:pt>
                  <c:pt idx="5">
                    <c:v>0.21081851067789203</c:v>
                  </c:pt>
                  <c:pt idx="6">
                    <c:v>0.47434164902525694</c:v>
                  </c:pt>
                  <c:pt idx="7">
                    <c:v>0.45946829173634074</c:v>
                  </c:pt>
                  <c:pt idx="8">
                    <c:v>0.34377582547616431</c:v>
                  </c:pt>
                  <c:pt idx="9">
                    <c:v>0.33333333333333331</c:v>
                  </c:pt>
                  <c:pt idx="10">
                    <c:v>0.33333333333333331</c:v>
                  </c:pt>
                  <c:pt idx="11">
                    <c:v>0.16666666666666671</c:v>
                  </c:pt>
                  <c:pt idx="12">
                    <c:v>0.25226248955475655</c:v>
                  </c:pt>
                  <c:pt idx="13">
                    <c:v>0.4330127018922193</c:v>
                  </c:pt>
                  <c:pt idx="14">
                    <c:v>0</c:v>
                  </c:pt>
                  <c:pt idx="15">
                    <c:v>0.28867513459481253</c:v>
                  </c:pt>
                  <c:pt idx="16">
                    <c:v>0.4330127018922193</c:v>
                  </c:pt>
                  <c:pt idx="17">
                    <c:v>0.28867513459481253</c:v>
                  </c:pt>
                  <c:pt idx="18">
                    <c:v>0.49082490860702116</c:v>
                  </c:pt>
                  <c:pt idx="19">
                    <c:v>0.47434164902525672</c:v>
                  </c:pt>
                  <c:pt idx="20">
                    <c:v>0.5</c:v>
                  </c:pt>
                  <c:pt idx="21">
                    <c:v>0.21081851067789192</c:v>
                  </c:pt>
                  <c:pt idx="22">
                    <c:v>0.70710678118654757</c:v>
                  </c:pt>
                </c:numCache>
              </c:numRef>
            </c:plus>
            <c:minus>
              <c:numRef>
                <c:f>'mutagenèse RYRE'!$C$11:$Y$11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45226701686664555</c:v>
                  </c:pt>
                  <c:pt idx="2">
                    <c:v>0.21081851067789195</c:v>
                  </c:pt>
                  <c:pt idx="3">
                    <c:v>0.25226248955475655</c:v>
                  </c:pt>
                  <c:pt idx="4">
                    <c:v>0.35355339059327379</c:v>
                  </c:pt>
                  <c:pt idx="5">
                    <c:v>0.21081851067789203</c:v>
                  </c:pt>
                  <c:pt idx="6">
                    <c:v>0.47434164902525694</c:v>
                  </c:pt>
                  <c:pt idx="7">
                    <c:v>0.45946829173634074</c:v>
                  </c:pt>
                  <c:pt idx="8">
                    <c:v>0.34377582547616431</c:v>
                  </c:pt>
                  <c:pt idx="9">
                    <c:v>0.33333333333333331</c:v>
                  </c:pt>
                  <c:pt idx="10">
                    <c:v>0.33333333333333331</c:v>
                  </c:pt>
                  <c:pt idx="11">
                    <c:v>0.16666666666666671</c:v>
                  </c:pt>
                  <c:pt idx="12">
                    <c:v>0.25226248955475655</c:v>
                  </c:pt>
                  <c:pt idx="13">
                    <c:v>0.4330127018922193</c:v>
                  </c:pt>
                  <c:pt idx="14">
                    <c:v>0</c:v>
                  </c:pt>
                  <c:pt idx="15">
                    <c:v>0.28867513459481253</c:v>
                  </c:pt>
                  <c:pt idx="16">
                    <c:v>0.4330127018922193</c:v>
                  </c:pt>
                  <c:pt idx="17">
                    <c:v>0.28867513459481253</c:v>
                  </c:pt>
                  <c:pt idx="18">
                    <c:v>0.49082490860702116</c:v>
                  </c:pt>
                  <c:pt idx="19">
                    <c:v>0.47434164902525672</c:v>
                  </c:pt>
                  <c:pt idx="20">
                    <c:v>0.5</c:v>
                  </c:pt>
                  <c:pt idx="21">
                    <c:v>0.21081851067789192</c:v>
                  </c:pt>
                  <c:pt idx="22">
                    <c:v>0.707106781186547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utagenèse RYRE'!$C$9:$Y$9</c:f>
              <c:strCache>
                <c:ptCount val="23"/>
                <c:pt idx="0">
                  <c:v>jn3</c:v>
                </c:pt>
                <c:pt idx="1">
                  <c:v>G06E107</c:v>
                </c:pt>
                <c:pt idx="2">
                  <c:v>JN2</c:v>
                </c:pt>
                <c:pt idx="3">
                  <c:v>G06E107-A4-7R100P-1</c:v>
                </c:pt>
                <c:pt idx="4">
                  <c:v>G06E107-A4-7R100P-2</c:v>
                </c:pt>
                <c:pt idx="5">
                  <c:v>G06E107-A4-7R100P-3</c:v>
                </c:pt>
                <c:pt idx="6">
                  <c:v>G06E107-A4-7R100P-4</c:v>
                </c:pt>
                <c:pt idx="7">
                  <c:v>G06E107-A4-7R100P-5</c:v>
                </c:pt>
                <c:pt idx="8">
                  <c:v>G06E107-A4-7F102S-1</c:v>
                </c:pt>
                <c:pt idx="9">
                  <c:v>G06E107-A4-7F102S-3</c:v>
                </c:pt>
                <c:pt idx="10">
                  <c:v>G06E107-A4-7F102S-4</c:v>
                </c:pt>
                <c:pt idx="11">
                  <c:v>G06E107-A4-7F102S-5</c:v>
                </c:pt>
                <c:pt idx="12">
                  <c:v>G06E107-A4-7F102S-6</c:v>
                </c:pt>
                <c:pt idx="13">
                  <c:v>G06E107-a4-A7F102SG120R-1</c:v>
                </c:pt>
                <c:pt idx="14">
                  <c:v>G06E107-a4-A7F102SG120R-2</c:v>
                </c:pt>
                <c:pt idx="15">
                  <c:v>G06E107-a4-A7F102SG120R-3</c:v>
                </c:pt>
                <c:pt idx="16">
                  <c:v>G06E107-a4-A7F102SG120R-4</c:v>
                </c:pt>
                <c:pt idx="17">
                  <c:v>G06E107-a4-A7F102SG120R-5</c:v>
                </c:pt>
                <c:pt idx="18">
                  <c:v>G06E107-A4-7S112R-1</c:v>
                </c:pt>
                <c:pt idx="19">
                  <c:v>G06E107-A4-7S112R-2</c:v>
                </c:pt>
                <c:pt idx="20">
                  <c:v>G06E107-A4-7S112R-3</c:v>
                </c:pt>
                <c:pt idx="21">
                  <c:v>G06E107-A4-7S112R-4</c:v>
                </c:pt>
                <c:pt idx="22">
                  <c:v>G06E107-A4-7S112R-7</c:v>
                </c:pt>
              </c:strCache>
            </c:strRef>
          </c:cat>
          <c:val>
            <c:numRef>
              <c:f>'mutagenèse RYRE'!$C$10:$Y$10</c:f>
              <c:numCache>
                <c:formatCode>General</c:formatCode>
                <c:ptCount val="23"/>
                <c:pt idx="0">
                  <c:v>1</c:v>
                </c:pt>
                <c:pt idx="1">
                  <c:v>3.7272727272727271</c:v>
                </c:pt>
                <c:pt idx="2">
                  <c:v>4.2</c:v>
                </c:pt>
                <c:pt idx="3">
                  <c:v>1.6363636363636365</c:v>
                </c:pt>
                <c:pt idx="4">
                  <c:v>1.5</c:v>
                </c:pt>
                <c:pt idx="5">
                  <c:v>1.8</c:v>
                </c:pt>
                <c:pt idx="6">
                  <c:v>1.7</c:v>
                </c:pt>
                <c:pt idx="7">
                  <c:v>1.8</c:v>
                </c:pt>
                <c:pt idx="8">
                  <c:v>1.4545454545454546</c:v>
                </c:pt>
                <c:pt idx="9">
                  <c:v>2</c:v>
                </c:pt>
                <c:pt idx="10">
                  <c:v>2</c:v>
                </c:pt>
                <c:pt idx="11">
                  <c:v>1.1111111111111112</c:v>
                </c:pt>
                <c:pt idx="12">
                  <c:v>1.3636363636363635</c:v>
                </c:pt>
                <c:pt idx="13">
                  <c:v>3.75</c:v>
                </c:pt>
                <c:pt idx="14">
                  <c:v>4</c:v>
                </c:pt>
                <c:pt idx="15">
                  <c:v>3.8333333333333335</c:v>
                </c:pt>
                <c:pt idx="16">
                  <c:v>3.75</c:v>
                </c:pt>
                <c:pt idx="17">
                  <c:v>3.8333333333333335</c:v>
                </c:pt>
                <c:pt idx="18">
                  <c:v>3.8181818181818183</c:v>
                </c:pt>
                <c:pt idx="19">
                  <c:v>3.7</c:v>
                </c:pt>
                <c:pt idx="20">
                  <c:v>3.6666666666666665</c:v>
                </c:pt>
                <c:pt idx="21">
                  <c:v>4.2</c:v>
                </c:pt>
                <c:pt idx="22">
                  <c:v>3.33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85-4482-810F-1F04DF2B8444}"/>
            </c:ext>
          </c:extLst>
        </c:ser>
        <c:ser>
          <c:idx val="1"/>
          <c:order val="1"/>
          <c:tx>
            <c:v>14DPI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utagenèse RYRE'!$C$13:$Y$13</c:f>
                <c:numCache>
                  <c:formatCode>General</c:formatCode>
                  <c:ptCount val="23"/>
                  <c:pt idx="0">
                    <c:v>0.14433756729740638</c:v>
                  </c:pt>
                  <c:pt idx="1">
                    <c:v>0.22613350843332272</c:v>
                  </c:pt>
                  <c:pt idx="2">
                    <c:v>0.23354968324845718</c:v>
                  </c:pt>
                  <c:pt idx="3">
                    <c:v>0.43779751788545651</c:v>
                  </c:pt>
                  <c:pt idx="4">
                    <c:v>0.35355339059327379</c:v>
                  </c:pt>
                  <c:pt idx="5">
                    <c:v>0.36893239368631087</c:v>
                  </c:pt>
                  <c:pt idx="6">
                    <c:v>0.43779751788545651</c:v>
                  </c:pt>
                  <c:pt idx="7">
                    <c:v>0.40824829046386302</c:v>
                  </c:pt>
                  <c:pt idx="8">
                    <c:v>0.2635231383473649</c:v>
                  </c:pt>
                  <c:pt idx="9">
                    <c:v>0.33333333333333343</c:v>
                  </c:pt>
                  <c:pt idx="10">
                    <c:v>0.4330127018922193</c:v>
                  </c:pt>
                  <c:pt idx="11">
                    <c:v>0.17677669529663689</c:v>
                  </c:pt>
                  <c:pt idx="12">
                    <c:v>0.33709993123162107</c:v>
                  </c:pt>
                  <c:pt idx="13">
                    <c:v>0.4330127018922193</c:v>
                  </c:pt>
                  <c:pt idx="14">
                    <c:v>0</c:v>
                  </c:pt>
                  <c:pt idx="15">
                    <c:v>0.28867513459481253</c:v>
                  </c:pt>
                  <c:pt idx="16">
                    <c:v>0.4330127018922193</c:v>
                  </c:pt>
                  <c:pt idx="17">
                    <c:v>0.28867513459481253</c:v>
                  </c:pt>
                  <c:pt idx="18">
                    <c:v>0.25746432527221819</c:v>
                  </c:pt>
                  <c:pt idx="19">
                    <c:v>0.21081851067789192</c:v>
                  </c:pt>
                  <c:pt idx="20">
                    <c:v>0.26352313834736529</c:v>
                  </c:pt>
                  <c:pt idx="21">
                    <c:v>0.25819888974716143</c:v>
                  </c:pt>
                  <c:pt idx="22">
                    <c:v>0.16666666666666669</c:v>
                  </c:pt>
                </c:numCache>
              </c:numRef>
            </c:plus>
            <c:minus>
              <c:numRef>
                <c:f>'mutagenèse RYRE'!$C$13:$Y$13</c:f>
                <c:numCache>
                  <c:formatCode>General</c:formatCode>
                  <c:ptCount val="23"/>
                  <c:pt idx="0">
                    <c:v>0.14433756729740638</c:v>
                  </c:pt>
                  <c:pt idx="1">
                    <c:v>0.22613350843332272</c:v>
                  </c:pt>
                  <c:pt idx="2">
                    <c:v>0.23354968324845718</c:v>
                  </c:pt>
                  <c:pt idx="3">
                    <c:v>0.43779751788545651</c:v>
                  </c:pt>
                  <c:pt idx="4">
                    <c:v>0.35355339059327379</c:v>
                  </c:pt>
                  <c:pt idx="5">
                    <c:v>0.36893239368631087</c:v>
                  </c:pt>
                  <c:pt idx="6">
                    <c:v>0.43779751788545651</c:v>
                  </c:pt>
                  <c:pt idx="7">
                    <c:v>0.40824829046386302</c:v>
                  </c:pt>
                  <c:pt idx="8">
                    <c:v>0.2635231383473649</c:v>
                  </c:pt>
                  <c:pt idx="9">
                    <c:v>0.33333333333333343</c:v>
                  </c:pt>
                  <c:pt idx="10">
                    <c:v>0.4330127018922193</c:v>
                  </c:pt>
                  <c:pt idx="11">
                    <c:v>0.17677669529663689</c:v>
                  </c:pt>
                  <c:pt idx="12">
                    <c:v>0.33709993123162107</c:v>
                  </c:pt>
                  <c:pt idx="13">
                    <c:v>0.4330127018922193</c:v>
                  </c:pt>
                  <c:pt idx="14">
                    <c:v>0</c:v>
                  </c:pt>
                  <c:pt idx="15">
                    <c:v>0.28867513459481253</c:v>
                  </c:pt>
                  <c:pt idx="16">
                    <c:v>0.4330127018922193</c:v>
                  </c:pt>
                  <c:pt idx="17">
                    <c:v>0.28867513459481253</c:v>
                  </c:pt>
                  <c:pt idx="18">
                    <c:v>0.25746432527221819</c:v>
                  </c:pt>
                  <c:pt idx="19">
                    <c:v>0.21081851067789192</c:v>
                  </c:pt>
                  <c:pt idx="20">
                    <c:v>0.26352313834736529</c:v>
                  </c:pt>
                  <c:pt idx="21">
                    <c:v>0.25819888974716143</c:v>
                  </c:pt>
                  <c:pt idx="22">
                    <c:v>0.166666666666666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utagenèse RYRE'!$C$9:$Y$9</c:f>
              <c:strCache>
                <c:ptCount val="23"/>
                <c:pt idx="0">
                  <c:v>jn3</c:v>
                </c:pt>
                <c:pt idx="1">
                  <c:v>G06E107</c:v>
                </c:pt>
                <c:pt idx="2">
                  <c:v>JN2</c:v>
                </c:pt>
                <c:pt idx="3">
                  <c:v>G06E107-A4-7R100P-1</c:v>
                </c:pt>
                <c:pt idx="4">
                  <c:v>G06E107-A4-7R100P-2</c:v>
                </c:pt>
                <c:pt idx="5">
                  <c:v>G06E107-A4-7R100P-3</c:v>
                </c:pt>
                <c:pt idx="6">
                  <c:v>G06E107-A4-7R100P-4</c:v>
                </c:pt>
                <c:pt idx="7">
                  <c:v>G06E107-A4-7R100P-5</c:v>
                </c:pt>
                <c:pt idx="8">
                  <c:v>G06E107-A4-7F102S-1</c:v>
                </c:pt>
                <c:pt idx="9">
                  <c:v>G06E107-A4-7F102S-3</c:v>
                </c:pt>
                <c:pt idx="10">
                  <c:v>G06E107-A4-7F102S-4</c:v>
                </c:pt>
                <c:pt idx="11">
                  <c:v>G06E107-A4-7F102S-5</c:v>
                </c:pt>
                <c:pt idx="12">
                  <c:v>G06E107-A4-7F102S-6</c:v>
                </c:pt>
                <c:pt idx="13">
                  <c:v>G06E107-a4-A7F102SG120R-1</c:v>
                </c:pt>
                <c:pt idx="14">
                  <c:v>G06E107-a4-A7F102SG120R-2</c:v>
                </c:pt>
                <c:pt idx="15">
                  <c:v>G06E107-a4-A7F102SG120R-3</c:v>
                </c:pt>
                <c:pt idx="16">
                  <c:v>G06E107-a4-A7F102SG120R-4</c:v>
                </c:pt>
                <c:pt idx="17">
                  <c:v>G06E107-a4-A7F102SG120R-5</c:v>
                </c:pt>
                <c:pt idx="18">
                  <c:v>G06E107-A4-7S112R-1</c:v>
                </c:pt>
                <c:pt idx="19">
                  <c:v>G06E107-A4-7S112R-2</c:v>
                </c:pt>
                <c:pt idx="20">
                  <c:v>G06E107-A4-7S112R-3</c:v>
                </c:pt>
                <c:pt idx="21">
                  <c:v>G06E107-A4-7S112R-4</c:v>
                </c:pt>
                <c:pt idx="22">
                  <c:v>G06E107-A4-7S112R-7</c:v>
                </c:pt>
              </c:strCache>
            </c:strRef>
          </c:cat>
          <c:val>
            <c:numRef>
              <c:f>'mutagenèse RYRE'!$C$12:$Y$12</c:f>
              <c:numCache>
                <c:formatCode>General</c:formatCode>
                <c:ptCount val="23"/>
                <c:pt idx="0">
                  <c:v>1.0833333333333333</c:v>
                </c:pt>
                <c:pt idx="1">
                  <c:v>4.25</c:v>
                </c:pt>
                <c:pt idx="2">
                  <c:v>4.2727272727272725</c:v>
                </c:pt>
                <c:pt idx="3">
                  <c:v>1.9</c:v>
                </c:pt>
                <c:pt idx="4">
                  <c:v>1.5</c:v>
                </c:pt>
                <c:pt idx="5">
                  <c:v>1.9</c:v>
                </c:pt>
                <c:pt idx="6">
                  <c:v>1.9</c:v>
                </c:pt>
                <c:pt idx="7">
                  <c:v>2</c:v>
                </c:pt>
                <c:pt idx="8">
                  <c:v>1.4444444444444444</c:v>
                </c:pt>
                <c:pt idx="9">
                  <c:v>2.2222222222222223</c:v>
                </c:pt>
                <c:pt idx="10">
                  <c:v>2</c:v>
                </c:pt>
                <c:pt idx="11">
                  <c:v>1.125</c:v>
                </c:pt>
                <c:pt idx="12">
                  <c:v>1.6363636363636365</c:v>
                </c:pt>
                <c:pt idx="13">
                  <c:v>3.75</c:v>
                </c:pt>
                <c:pt idx="14">
                  <c:v>4</c:v>
                </c:pt>
                <c:pt idx="15">
                  <c:v>3.8333333333333335</c:v>
                </c:pt>
                <c:pt idx="16">
                  <c:v>3.75</c:v>
                </c:pt>
                <c:pt idx="17">
                  <c:v>3.8333333333333335</c:v>
                </c:pt>
                <c:pt idx="18">
                  <c:v>4.083333333333333</c:v>
                </c:pt>
                <c:pt idx="19">
                  <c:v>4.2</c:v>
                </c:pt>
                <c:pt idx="20">
                  <c:v>4.4444444444444446</c:v>
                </c:pt>
                <c:pt idx="21">
                  <c:v>4.4000000000000004</c:v>
                </c:pt>
                <c:pt idx="22">
                  <c:v>4.11111111111111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385-4482-810F-1F04DF2B84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85033568"/>
        <c:axId val="1185033024"/>
      </c:barChart>
      <c:catAx>
        <c:axId val="118503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185033024"/>
        <c:crosses val="autoZero"/>
        <c:auto val="1"/>
        <c:lblAlgn val="ctr"/>
        <c:lblOffset val="100"/>
        <c:noMultiLvlLbl val="0"/>
      </c:catAx>
      <c:valAx>
        <c:axId val="1185033024"/>
        <c:scaling>
          <c:orientation val="minMax"/>
          <c:max val="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185033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fr-FR" dirty="0"/>
              <a:t>15.22.4.1 (</a:t>
            </a:r>
            <a:r>
              <a:rPr lang="fr-FR" i="1" dirty="0"/>
              <a:t>Rlm3</a:t>
            </a:r>
            <a:r>
              <a:rPr lang="fr-FR" dirty="0"/>
              <a:t>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10DPI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utagenèse RYRE'!$C$3:$Y$3</c:f>
                <c:numCache>
                  <c:formatCode>General</c:formatCode>
                  <c:ptCount val="23"/>
                  <c:pt idx="0">
                    <c:v>0.5464532103584997</c:v>
                  </c:pt>
                  <c:pt idx="1">
                    <c:v>0.25</c:v>
                  </c:pt>
                  <c:pt idx="2">
                    <c:v>0.25877458475338283</c:v>
                  </c:pt>
                  <c:pt idx="3">
                    <c:v>0.5986094998689323</c:v>
                  </c:pt>
                  <c:pt idx="4">
                    <c:v>0.70064904974537079</c:v>
                  </c:pt>
                  <c:pt idx="5">
                    <c:v>0.65017480167049901</c:v>
                  </c:pt>
                  <c:pt idx="6">
                    <c:v>0.68755165095232862</c:v>
                  </c:pt>
                  <c:pt idx="7">
                    <c:v>0.7821396449755148</c:v>
                  </c:pt>
                  <c:pt idx="8">
                    <c:v>0.23354968324845718</c:v>
                  </c:pt>
                  <c:pt idx="9">
                    <c:v>0.4156047072968167</c:v>
                  </c:pt>
                  <c:pt idx="10">
                    <c:v>0.26111648393354636</c:v>
                  </c:pt>
                  <c:pt idx="11">
                    <c:v>0.26111648393354636</c:v>
                  </c:pt>
                  <c:pt idx="12">
                    <c:v>0.8232726023485647</c:v>
                  </c:pt>
                  <c:pt idx="13">
                    <c:v>0.53452248382484879</c:v>
                  </c:pt>
                  <c:pt idx="14">
                    <c:v>0.41726148019814008</c:v>
                  </c:pt>
                  <c:pt idx="15">
                    <c:v>0.56694670951384085</c:v>
                  </c:pt>
                  <c:pt idx="16">
                    <c:v>0.75297030865385772</c:v>
                  </c:pt>
                  <c:pt idx="17">
                    <c:v>0.67810134093026875</c:v>
                  </c:pt>
                  <c:pt idx="18">
                    <c:v>0.35355339059327379</c:v>
                  </c:pt>
                  <c:pt idx="19">
                    <c:v>0.2635231383473649</c:v>
                  </c:pt>
                  <c:pt idx="20">
                    <c:v>0.2672612419124244</c:v>
                  </c:pt>
                  <c:pt idx="21">
                    <c:v>0.25</c:v>
                  </c:pt>
                  <c:pt idx="22">
                    <c:v>0.63245553203367588</c:v>
                  </c:pt>
                </c:numCache>
              </c:numRef>
            </c:plus>
            <c:minus>
              <c:numRef>
                <c:f>'mutagenèse RYRE'!$C$3:$Y$3</c:f>
                <c:numCache>
                  <c:formatCode>General</c:formatCode>
                  <c:ptCount val="23"/>
                  <c:pt idx="0">
                    <c:v>0.5464532103584997</c:v>
                  </c:pt>
                  <c:pt idx="1">
                    <c:v>0.25</c:v>
                  </c:pt>
                  <c:pt idx="2">
                    <c:v>0.25877458475338283</c:v>
                  </c:pt>
                  <c:pt idx="3">
                    <c:v>0.5986094998689323</c:v>
                  </c:pt>
                  <c:pt idx="4">
                    <c:v>0.70064904974537079</c:v>
                  </c:pt>
                  <c:pt idx="5">
                    <c:v>0.65017480167049901</c:v>
                  </c:pt>
                  <c:pt idx="6">
                    <c:v>0.68755165095232862</c:v>
                  </c:pt>
                  <c:pt idx="7">
                    <c:v>0.7821396449755148</c:v>
                  </c:pt>
                  <c:pt idx="8">
                    <c:v>0.23354968324845718</c:v>
                  </c:pt>
                  <c:pt idx="9">
                    <c:v>0.4156047072968167</c:v>
                  </c:pt>
                  <c:pt idx="10">
                    <c:v>0.26111648393354636</c:v>
                  </c:pt>
                  <c:pt idx="11">
                    <c:v>0.26111648393354636</c:v>
                  </c:pt>
                  <c:pt idx="12">
                    <c:v>0.8232726023485647</c:v>
                  </c:pt>
                  <c:pt idx="13">
                    <c:v>0.53452248382484879</c:v>
                  </c:pt>
                  <c:pt idx="14">
                    <c:v>0.41726148019814008</c:v>
                  </c:pt>
                  <c:pt idx="15">
                    <c:v>0.56694670951384085</c:v>
                  </c:pt>
                  <c:pt idx="16">
                    <c:v>0.75297030865385772</c:v>
                  </c:pt>
                  <c:pt idx="17">
                    <c:v>0.67810134093026875</c:v>
                  </c:pt>
                  <c:pt idx="18">
                    <c:v>0.35355339059327379</c:v>
                  </c:pt>
                  <c:pt idx="19">
                    <c:v>0.2635231383473649</c:v>
                  </c:pt>
                  <c:pt idx="20">
                    <c:v>0.2672612419124244</c:v>
                  </c:pt>
                  <c:pt idx="21">
                    <c:v>0.25</c:v>
                  </c:pt>
                  <c:pt idx="22">
                    <c:v>0.632455532033675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utagenèse RYRE'!$C$1:$Y$1</c:f>
              <c:strCache>
                <c:ptCount val="23"/>
                <c:pt idx="0">
                  <c:v>jn3</c:v>
                </c:pt>
                <c:pt idx="1">
                  <c:v>G06E107</c:v>
                </c:pt>
                <c:pt idx="2">
                  <c:v>JN2</c:v>
                </c:pt>
                <c:pt idx="3">
                  <c:v>G06E107-A4-7R100P-1</c:v>
                </c:pt>
                <c:pt idx="4">
                  <c:v>G06E107-A4-7R100P-2</c:v>
                </c:pt>
                <c:pt idx="5">
                  <c:v>G06E107-A4-7R100P-3</c:v>
                </c:pt>
                <c:pt idx="6">
                  <c:v>G06E107-A4-7R100P-4</c:v>
                </c:pt>
                <c:pt idx="7">
                  <c:v>G06E107-A4-7R100P-5</c:v>
                </c:pt>
                <c:pt idx="8">
                  <c:v>G06E107-A4-7F102S-1</c:v>
                </c:pt>
                <c:pt idx="9">
                  <c:v>G06E107-A4-7F102S-3</c:v>
                </c:pt>
                <c:pt idx="10">
                  <c:v>G06E107-A4-7F102S-4</c:v>
                </c:pt>
                <c:pt idx="11">
                  <c:v>G06E107-A4-7F102S-5</c:v>
                </c:pt>
                <c:pt idx="12">
                  <c:v>G06E107-A4-7F102S-6</c:v>
                </c:pt>
                <c:pt idx="13">
                  <c:v>G06E107-a4-A7F102SG120R-1</c:v>
                </c:pt>
                <c:pt idx="14">
                  <c:v>G06E107-a4-A7F102SG120R-2</c:v>
                </c:pt>
                <c:pt idx="15">
                  <c:v>G06E107-a4-A7F102SG120R-3</c:v>
                </c:pt>
                <c:pt idx="16">
                  <c:v>G06E107-a4-A7F102SG120R-4</c:v>
                </c:pt>
                <c:pt idx="17">
                  <c:v>G06E107-a4-A7F102SG120R-5</c:v>
                </c:pt>
                <c:pt idx="18">
                  <c:v>G06E107-A4-7S112R-1</c:v>
                </c:pt>
                <c:pt idx="19">
                  <c:v>G06E107-A4-7S112R-2</c:v>
                </c:pt>
                <c:pt idx="20">
                  <c:v>G06E107-A4-7S112R-3</c:v>
                </c:pt>
                <c:pt idx="21">
                  <c:v>G06E107-A4-7S112R-4</c:v>
                </c:pt>
                <c:pt idx="22">
                  <c:v>G06E107-A4-7S112R-7</c:v>
                </c:pt>
              </c:strCache>
            </c:strRef>
          </c:cat>
          <c:val>
            <c:numRef>
              <c:f>'mutagenèse RYRE'!$C$2:$Y$2</c:f>
              <c:numCache>
                <c:formatCode>General</c:formatCode>
                <c:ptCount val="23"/>
                <c:pt idx="0">
                  <c:v>3.7777777777777777</c:v>
                </c:pt>
                <c:pt idx="1">
                  <c:v>1.3333333333333333</c:v>
                </c:pt>
                <c:pt idx="2">
                  <c:v>4.625</c:v>
                </c:pt>
                <c:pt idx="3">
                  <c:v>2.8</c:v>
                </c:pt>
                <c:pt idx="4">
                  <c:v>3.1818181818181817</c:v>
                </c:pt>
                <c:pt idx="5">
                  <c:v>3.0909090909090908</c:v>
                </c:pt>
                <c:pt idx="6">
                  <c:v>3.0909090909090908</c:v>
                </c:pt>
                <c:pt idx="7">
                  <c:v>2.9166666666666665</c:v>
                </c:pt>
                <c:pt idx="8">
                  <c:v>4.2727272727272725</c:v>
                </c:pt>
                <c:pt idx="9">
                  <c:v>4.0909090909090908</c:v>
                </c:pt>
                <c:pt idx="10">
                  <c:v>4.5454545454545459</c:v>
                </c:pt>
                <c:pt idx="11">
                  <c:v>4.5454545454545459</c:v>
                </c:pt>
                <c:pt idx="12">
                  <c:v>3.6</c:v>
                </c:pt>
                <c:pt idx="13">
                  <c:v>3</c:v>
                </c:pt>
                <c:pt idx="14">
                  <c:v>2.125</c:v>
                </c:pt>
                <c:pt idx="15">
                  <c:v>2.4285714285714284</c:v>
                </c:pt>
                <c:pt idx="16">
                  <c:v>2.625</c:v>
                </c:pt>
                <c:pt idx="17">
                  <c:v>2.875</c:v>
                </c:pt>
                <c:pt idx="18">
                  <c:v>1.3333333333333333</c:v>
                </c:pt>
                <c:pt idx="19">
                  <c:v>1.4444444444444444</c:v>
                </c:pt>
                <c:pt idx="20">
                  <c:v>1.5</c:v>
                </c:pt>
                <c:pt idx="21">
                  <c:v>1.3333333333333333</c:v>
                </c:pt>
                <c:pt idx="2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28-4B09-B664-D43AF538F0CC}"/>
            </c:ext>
          </c:extLst>
        </c:ser>
        <c:ser>
          <c:idx val="1"/>
          <c:order val="1"/>
          <c:tx>
            <c:v>14 DPI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utagenèse RYRE'!$C$5:$Y$5</c:f>
                <c:numCache>
                  <c:formatCode>General</c:formatCode>
                  <c:ptCount val="23"/>
                  <c:pt idx="0">
                    <c:v>0.33333333333333276</c:v>
                  </c:pt>
                  <c:pt idx="1">
                    <c:v>0.58333333333333326</c:v>
                  </c:pt>
                  <c:pt idx="2">
                    <c:v>0</c:v>
                  </c:pt>
                  <c:pt idx="3">
                    <c:v>0.64666979068286312</c:v>
                  </c:pt>
                  <c:pt idx="4">
                    <c:v>0.52223296786709339</c:v>
                  </c:pt>
                  <c:pt idx="5">
                    <c:v>0.40451991747794486</c:v>
                  </c:pt>
                  <c:pt idx="6">
                    <c:v>0.46709936649691358</c:v>
                  </c:pt>
                  <c:pt idx="7">
                    <c:v>0.49236596391733073</c:v>
                  </c:pt>
                  <c:pt idx="8">
                    <c:v>0</c:v>
                  </c:pt>
                  <c:pt idx="9">
                    <c:v>0.2335496832484569</c:v>
                  </c:pt>
                  <c:pt idx="10">
                    <c:v>0</c:v>
                  </c:pt>
                  <c:pt idx="11">
                    <c:v>0.15075567228888181</c:v>
                  </c:pt>
                  <c:pt idx="12">
                    <c:v>0.34377582547616503</c:v>
                  </c:pt>
                  <c:pt idx="13">
                    <c:v>0.51754916950676566</c:v>
                  </c:pt>
                  <c:pt idx="14">
                    <c:v>0.51754916950676566</c:v>
                  </c:pt>
                  <c:pt idx="15">
                    <c:v>0.48795003647426632</c:v>
                  </c:pt>
                  <c:pt idx="16">
                    <c:v>0.49159604012508762</c:v>
                  </c:pt>
                  <c:pt idx="17">
                    <c:v>0</c:v>
                  </c:pt>
                  <c:pt idx="18">
                    <c:v>0.37638632635454045</c:v>
                  </c:pt>
                  <c:pt idx="19">
                    <c:v>0.36893239368631087</c:v>
                  </c:pt>
                  <c:pt idx="20">
                    <c:v>0.50689687752485157</c:v>
                  </c:pt>
                  <c:pt idx="21">
                    <c:v>0.42491829279939874</c:v>
                  </c:pt>
                  <c:pt idx="22">
                    <c:v>0.27386127875258298</c:v>
                  </c:pt>
                </c:numCache>
              </c:numRef>
            </c:plus>
            <c:minus>
              <c:numRef>
                <c:f>'mutagenèse RYRE'!$C$5:$Y$5</c:f>
                <c:numCache>
                  <c:formatCode>General</c:formatCode>
                  <c:ptCount val="23"/>
                  <c:pt idx="0">
                    <c:v>0.33333333333333276</c:v>
                  </c:pt>
                  <c:pt idx="1">
                    <c:v>0.58333333333333326</c:v>
                  </c:pt>
                  <c:pt idx="2">
                    <c:v>0</c:v>
                  </c:pt>
                  <c:pt idx="3">
                    <c:v>0.64666979068286312</c:v>
                  </c:pt>
                  <c:pt idx="4">
                    <c:v>0.52223296786709339</c:v>
                  </c:pt>
                  <c:pt idx="5">
                    <c:v>0.40451991747794486</c:v>
                  </c:pt>
                  <c:pt idx="6">
                    <c:v>0.46709936649691358</c:v>
                  </c:pt>
                  <c:pt idx="7">
                    <c:v>0.49236596391733073</c:v>
                  </c:pt>
                  <c:pt idx="8">
                    <c:v>0</c:v>
                  </c:pt>
                  <c:pt idx="9">
                    <c:v>0.2335496832484569</c:v>
                  </c:pt>
                  <c:pt idx="10">
                    <c:v>0</c:v>
                  </c:pt>
                  <c:pt idx="11">
                    <c:v>0.15075567228888181</c:v>
                  </c:pt>
                  <c:pt idx="12">
                    <c:v>0.34377582547616503</c:v>
                  </c:pt>
                  <c:pt idx="13">
                    <c:v>0.51754916950676566</c:v>
                  </c:pt>
                  <c:pt idx="14">
                    <c:v>0.51754916950676566</c:v>
                  </c:pt>
                  <c:pt idx="15">
                    <c:v>0.48795003647426632</c:v>
                  </c:pt>
                  <c:pt idx="16">
                    <c:v>0.49159604012508762</c:v>
                  </c:pt>
                  <c:pt idx="17">
                    <c:v>0</c:v>
                  </c:pt>
                  <c:pt idx="18">
                    <c:v>0.37638632635454045</c:v>
                  </c:pt>
                  <c:pt idx="19">
                    <c:v>0.36893239368631087</c:v>
                  </c:pt>
                  <c:pt idx="20">
                    <c:v>0.50689687752485157</c:v>
                  </c:pt>
                  <c:pt idx="21">
                    <c:v>0.42491829279939874</c:v>
                  </c:pt>
                  <c:pt idx="22">
                    <c:v>0.27386127875258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utagenèse RYRE'!$C$1:$Y$1</c:f>
              <c:strCache>
                <c:ptCount val="23"/>
                <c:pt idx="0">
                  <c:v>jn3</c:v>
                </c:pt>
                <c:pt idx="1">
                  <c:v>G06E107</c:v>
                </c:pt>
                <c:pt idx="2">
                  <c:v>JN2</c:v>
                </c:pt>
                <c:pt idx="3">
                  <c:v>G06E107-A4-7R100P-1</c:v>
                </c:pt>
                <c:pt idx="4">
                  <c:v>G06E107-A4-7R100P-2</c:v>
                </c:pt>
                <c:pt idx="5">
                  <c:v>G06E107-A4-7R100P-3</c:v>
                </c:pt>
                <c:pt idx="6">
                  <c:v>G06E107-A4-7R100P-4</c:v>
                </c:pt>
                <c:pt idx="7">
                  <c:v>G06E107-A4-7R100P-5</c:v>
                </c:pt>
                <c:pt idx="8">
                  <c:v>G06E107-A4-7F102S-1</c:v>
                </c:pt>
                <c:pt idx="9">
                  <c:v>G06E107-A4-7F102S-3</c:v>
                </c:pt>
                <c:pt idx="10">
                  <c:v>G06E107-A4-7F102S-4</c:v>
                </c:pt>
                <c:pt idx="11">
                  <c:v>G06E107-A4-7F102S-5</c:v>
                </c:pt>
                <c:pt idx="12">
                  <c:v>G06E107-A4-7F102S-6</c:v>
                </c:pt>
                <c:pt idx="13">
                  <c:v>G06E107-a4-A7F102SG120R-1</c:v>
                </c:pt>
                <c:pt idx="14">
                  <c:v>G06E107-a4-A7F102SG120R-2</c:v>
                </c:pt>
                <c:pt idx="15">
                  <c:v>G06E107-a4-A7F102SG120R-3</c:v>
                </c:pt>
                <c:pt idx="16">
                  <c:v>G06E107-a4-A7F102SG120R-4</c:v>
                </c:pt>
                <c:pt idx="17">
                  <c:v>G06E107-a4-A7F102SG120R-5</c:v>
                </c:pt>
                <c:pt idx="18">
                  <c:v>G06E107-A4-7S112R-1</c:v>
                </c:pt>
                <c:pt idx="19">
                  <c:v>G06E107-A4-7S112R-2</c:v>
                </c:pt>
                <c:pt idx="20">
                  <c:v>G06E107-A4-7S112R-3</c:v>
                </c:pt>
                <c:pt idx="21">
                  <c:v>G06E107-A4-7S112R-4</c:v>
                </c:pt>
                <c:pt idx="22">
                  <c:v>G06E107-A4-7S112R-7</c:v>
                </c:pt>
              </c:strCache>
            </c:strRef>
          </c:cat>
          <c:val>
            <c:numRef>
              <c:f>'mutagenèse RYRE'!$C$4:$Y$4</c:f>
              <c:numCache>
                <c:formatCode>General</c:formatCode>
                <c:ptCount val="23"/>
                <c:pt idx="0">
                  <c:v>4.0999999999999996</c:v>
                </c:pt>
                <c:pt idx="1">
                  <c:v>1.8888888888888888</c:v>
                </c:pt>
                <c:pt idx="2">
                  <c:v>5</c:v>
                </c:pt>
                <c:pt idx="3">
                  <c:v>4.2</c:v>
                </c:pt>
                <c:pt idx="4">
                  <c:v>4.3</c:v>
                </c:pt>
                <c:pt idx="5">
                  <c:v>4.6363636363636367</c:v>
                </c:pt>
                <c:pt idx="6">
                  <c:v>4.4545454545454541</c:v>
                </c:pt>
                <c:pt idx="7">
                  <c:v>4.333333333333333</c:v>
                </c:pt>
                <c:pt idx="8">
                  <c:v>5</c:v>
                </c:pt>
                <c:pt idx="9">
                  <c:v>5.2727272727272725</c:v>
                </c:pt>
                <c:pt idx="10">
                  <c:v>5</c:v>
                </c:pt>
                <c:pt idx="11">
                  <c:v>5.0909090909090908</c:v>
                </c:pt>
                <c:pt idx="12">
                  <c:v>5.4545454545454541</c:v>
                </c:pt>
                <c:pt idx="13">
                  <c:v>3.15</c:v>
                </c:pt>
                <c:pt idx="14">
                  <c:v>3.35</c:v>
                </c:pt>
                <c:pt idx="15">
                  <c:v>3.25</c:v>
                </c:pt>
                <c:pt idx="16">
                  <c:v>3.1666666666666665</c:v>
                </c:pt>
                <c:pt idx="17">
                  <c:v>3</c:v>
                </c:pt>
                <c:pt idx="18">
                  <c:v>1.8333333333333333</c:v>
                </c:pt>
                <c:pt idx="19">
                  <c:v>1.9</c:v>
                </c:pt>
                <c:pt idx="20">
                  <c:v>2.5555555555555554</c:v>
                </c:pt>
                <c:pt idx="21">
                  <c:v>2.5</c:v>
                </c:pt>
                <c:pt idx="22">
                  <c:v>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28-4B09-B664-D43AF538F0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8481504"/>
        <c:axId val="1348479328"/>
      </c:barChart>
      <c:catAx>
        <c:axId val="1348481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348479328"/>
        <c:crosses val="autoZero"/>
        <c:auto val="1"/>
        <c:lblAlgn val="ctr"/>
        <c:lblOffset val="100"/>
        <c:noMultiLvlLbl val="0"/>
      </c:catAx>
      <c:valAx>
        <c:axId val="1348479328"/>
        <c:scaling>
          <c:orientation val="minMax"/>
          <c:max val="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348481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5056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1316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3386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1385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8716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8585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5553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4725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9640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2953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2427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6345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815825" y="13500850"/>
            <a:ext cx="10840369" cy="2501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30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4. </a:t>
            </a:r>
            <a:r>
              <a:rPr lang="en-US" b="1" dirty="0" smtClean="0"/>
              <a:t>Effect of mutations </a:t>
            </a:r>
            <a:r>
              <a:rPr lang="en-US" b="1" dirty="0"/>
              <a:t>in </a:t>
            </a:r>
            <a:r>
              <a:rPr lang="en-US" b="1" dirty="0" smtClean="0"/>
              <a:t>AvrLm4-7 on the ability </a:t>
            </a:r>
            <a:r>
              <a:rPr lang="en-US" b="1" dirty="0"/>
              <a:t>to suppress Rlm3-mediated </a:t>
            </a:r>
            <a:r>
              <a:rPr lang="en-US" b="1" dirty="0" smtClean="0"/>
              <a:t>recognition and to induce Rlm4 and Rlm7-mediated recognition</a:t>
            </a:r>
            <a:endParaRPr lang="fr-FR" dirty="0"/>
          </a:p>
          <a:p>
            <a:pPr algn="just">
              <a:lnSpc>
                <a:spcPct val="107000"/>
              </a:lnSpc>
              <a:spcAft>
                <a:spcPts val="300"/>
              </a:spcAft>
            </a:pP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Wild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type isolates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G06-E107 (A3a4a7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),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JN3 (a3A4A7) and JN2 (a3a4A7),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as well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s G06-E107 </a:t>
            </a:r>
            <a:r>
              <a:rPr lang="en-US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transformants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carrying AvrLm4-7 alleles with mutations at amino acids R</a:t>
            </a:r>
            <a:r>
              <a:rPr lang="en-US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00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, F</a:t>
            </a:r>
            <a:r>
              <a:rPr lang="en-US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02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, S</a:t>
            </a:r>
            <a:r>
              <a:rPr lang="en-US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12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and / or G</a:t>
            </a:r>
            <a:r>
              <a:rPr lang="en-US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20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were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oculated onto cotyledons of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ultivars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carrying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lm3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5.22.4.1), </a:t>
            </a:r>
            <a:r>
              <a:rPr lang="en-US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Rlm7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(15.23.4.1) or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lm4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Pixel). Pathogenicity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was measured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0 and 14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days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post-inoculation (DPI)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sults are expressed as a mean scoring using the IMASCORE rating comprising six infection classes (IC), where IC1 to IC3 correspond to resistance, and IC4 to IC6 to </a:t>
            </a:r>
            <a:r>
              <a:rPr lang="en-US">
                <a:latin typeface="Times New Roman" panose="02020603050405020304" pitchFamily="18" charset="0"/>
                <a:ea typeface="Times New Roman" panose="02020603050405020304" pitchFamily="18" charset="0"/>
              </a:rPr>
              <a:t>susceptibility </a:t>
            </a:r>
            <a:r>
              <a:rPr lang="en-US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[50]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Error bars indicate the standard deviation of technical replicates. </a:t>
            </a:r>
            <a:endParaRPr lang="fr-FR" sz="2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5648748"/>
              </p:ext>
            </p:extLst>
          </p:nvPr>
        </p:nvGraphicFramePr>
        <p:xfrm>
          <a:off x="2291513" y="9322550"/>
          <a:ext cx="8525170" cy="4178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7288940"/>
              </p:ext>
            </p:extLst>
          </p:nvPr>
        </p:nvGraphicFramePr>
        <p:xfrm>
          <a:off x="2090792" y="312235"/>
          <a:ext cx="8725889" cy="41153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7393694"/>
              </p:ext>
            </p:extLst>
          </p:nvPr>
        </p:nvGraphicFramePr>
        <p:xfrm>
          <a:off x="2291512" y="4564907"/>
          <a:ext cx="8525169" cy="4265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905530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567</TotalTime>
  <Words>148</Words>
  <Application>Microsoft Office PowerPoint</Application>
  <PresentationFormat>Personnalisé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sabelle Fudal</dc:creator>
  <cp:lastModifiedBy>Isabelle Fudal</cp:lastModifiedBy>
  <cp:revision>25</cp:revision>
  <dcterms:created xsi:type="dcterms:W3CDTF">2021-07-14T15:02:05Z</dcterms:created>
  <dcterms:modified xsi:type="dcterms:W3CDTF">2022-06-21T15:01:12Z</dcterms:modified>
</cp:coreProperties>
</file>